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0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2" clrIdx="0"/>
  <p:cmAuthor id="2" name="Microsoft Office User" initials="Office" lastIdx="6" clrIdx="1"/>
  <p:cmAuthor id="3" name="Laetitia Comps-Agrar" initials="LCA" lastIdx="1" clrIdx="2">
    <p:extLst>
      <p:ext uri="{19B8F6BF-5375-455C-9EA6-DF929625EA0E}">
        <p15:presenceInfo xmlns:p15="http://schemas.microsoft.com/office/powerpoint/2012/main" userId="Laetitia Comps-Agra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39" autoAdjust="0"/>
    <p:restoredTop sz="94141" autoAdjust="0"/>
  </p:normalViewPr>
  <p:slideViewPr>
    <p:cSldViewPr snapToGrid="0" snapToObjects="1">
      <p:cViewPr varScale="1">
        <p:scale>
          <a:sx n="53" d="100"/>
          <a:sy n="53" d="100"/>
        </p:scale>
        <p:origin x="2394" y="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2DEF5-F50D-40CB-B0C7-37A9663CE3B6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F4862D-3836-4C43-BD89-E5BE2B1EDE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713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7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794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77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609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68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51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286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151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389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127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72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4D2AB4-E2A6-F54B-852B-1417EA8D3450}" type="datetimeFigureOut">
              <a:rPr lang="en-US" smtClean="0"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C5375-9614-CF42-8ECA-50221B42F5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398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xmlns="" id="{934C516A-F2DD-BA42-B196-F47338B43483}"/>
              </a:ext>
            </a:extLst>
          </p:cNvPr>
          <p:cNvGrpSpPr/>
          <p:nvPr/>
        </p:nvGrpSpPr>
        <p:grpSpPr>
          <a:xfrm>
            <a:off x="1352982" y="929898"/>
            <a:ext cx="3980414" cy="3443955"/>
            <a:chOff x="0" y="28943"/>
            <a:chExt cx="4521645" cy="3913111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8A9DF23D-7D5F-264A-9AF4-6FCF84F8A42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03" t="13724" r="29535" b="19318"/>
            <a:stretch/>
          </p:blipFill>
          <p:spPr bwMode="auto">
            <a:xfrm>
              <a:off x="0" y="437968"/>
              <a:ext cx="3866696" cy="3504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TextBox 6">
              <a:extLst>
                <a:ext uri="{FF2B5EF4-FFF2-40B4-BE49-F238E27FC236}">
                  <a16:creationId xmlns:a16="http://schemas.microsoft.com/office/drawing/2014/main" xmlns="" id="{98022F9D-9D0A-5144-8FAF-C3AE657ED3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4686" y="38104"/>
              <a:ext cx="805815" cy="2959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4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(a) PBS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xmlns="" id="{F6D32558-5852-FE4E-89BF-2A5159387C22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593071" y="353921"/>
              <a:ext cx="1449730" cy="0"/>
            </a:xfrm>
            <a:prstGeom prst="line">
              <a:avLst/>
            </a:prstGeom>
            <a:noFill/>
            <a:ln w="25400">
              <a:solidFill>
                <a:schemeClr val="accent1"/>
              </a:solidFill>
              <a:round/>
              <a:headEnd/>
              <a:tailEnd/>
            </a:ln>
            <a:effectLst>
              <a:outerShdw blurRad="40000" dist="20000" dir="5400000" rotWithShape="0">
                <a:srgbClr val="80808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" name="TextBox 8">
              <a:extLst>
                <a:ext uri="{FF2B5EF4-FFF2-40B4-BE49-F238E27FC236}">
                  <a16:creationId xmlns:a16="http://schemas.microsoft.com/office/drawing/2014/main" xmlns="" id="{D407B1CF-DA6C-504B-990C-6A50F91624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4226" y="463628"/>
              <a:ext cx="1429825" cy="2885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0  18                   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9">
              <a:extLst>
                <a:ext uri="{FF2B5EF4-FFF2-40B4-BE49-F238E27FC236}">
                  <a16:creationId xmlns:a16="http://schemas.microsoft.com/office/drawing/2014/main" xmlns="" id="{1634CD15-1EC1-7A41-A5A6-844A96E853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83621" y="478000"/>
              <a:ext cx="1429825" cy="2885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0  18                   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10">
              <a:extLst>
                <a:ext uri="{FF2B5EF4-FFF2-40B4-BE49-F238E27FC236}">
                  <a16:creationId xmlns:a16="http://schemas.microsoft.com/office/drawing/2014/main" xmlns="" id="{31ADECA8-A809-CA48-BD71-0373095E62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1007" y="478000"/>
              <a:ext cx="1471707" cy="2885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0   18                   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11">
              <a:extLst>
                <a:ext uri="{FF2B5EF4-FFF2-40B4-BE49-F238E27FC236}">
                  <a16:creationId xmlns:a16="http://schemas.microsoft.com/office/drawing/2014/main" xmlns="" id="{D189B2E1-E812-2843-8585-1EABF6D2EF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91820" y="478000"/>
              <a:ext cx="1429825" cy="2885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 0   18                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12">
              <a:extLst>
                <a:ext uri="{FF2B5EF4-FFF2-40B4-BE49-F238E27FC236}">
                  <a16:creationId xmlns:a16="http://schemas.microsoft.com/office/drawing/2014/main" xmlns="" id="{BFBAA9F0-97EE-2645-8893-78121B58DB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45639" y="28943"/>
              <a:ext cx="923926" cy="2959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4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(b) IMDM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xmlns="" id="{A0607C2D-01D8-8E44-89EA-78A7FDD6B28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372285" y="344853"/>
              <a:ext cx="1449730" cy="0"/>
            </a:xfrm>
            <a:prstGeom prst="line">
              <a:avLst/>
            </a:prstGeom>
            <a:noFill/>
            <a:ln w="25400">
              <a:solidFill>
                <a:schemeClr val="accent1"/>
              </a:solidFill>
              <a:round/>
              <a:headEnd/>
              <a:tailEnd/>
            </a:ln>
            <a:effectLst>
              <a:outerShdw blurRad="40000" dist="20000" dir="5400000" rotWithShape="0">
                <a:srgbClr val="80808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8" name="TextBox 14">
              <a:extLst>
                <a:ext uri="{FF2B5EF4-FFF2-40B4-BE49-F238E27FC236}">
                  <a16:creationId xmlns:a16="http://schemas.microsoft.com/office/drawing/2014/main" xmlns="" id="{6D2A42DC-10E0-8046-8599-C5F32A057B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7076" y="872382"/>
              <a:ext cx="720091" cy="3835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Non-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Reducing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15">
              <a:extLst>
                <a:ext uri="{FF2B5EF4-FFF2-40B4-BE49-F238E27FC236}">
                  <a16:creationId xmlns:a16="http://schemas.microsoft.com/office/drawing/2014/main" xmlns="" id="{A2200D68-A6F8-A742-A9D7-80F55C221A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29838" y="867680"/>
              <a:ext cx="762001" cy="3835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Reduced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with DTT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16">
              <a:extLst>
                <a:ext uri="{FF2B5EF4-FFF2-40B4-BE49-F238E27FC236}">
                  <a16:creationId xmlns:a16="http://schemas.microsoft.com/office/drawing/2014/main" xmlns="" id="{8ECEE27C-575B-BE4C-BD08-9CC9F78C77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2286" y="867680"/>
              <a:ext cx="762001" cy="3835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Reduced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with DTT</a:t>
              </a:r>
              <a:endParaRPr lang="en-US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17">
              <a:extLst>
                <a:ext uri="{FF2B5EF4-FFF2-40B4-BE49-F238E27FC236}">
                  <a16:creationId xmlns:a16="http://schemas.microsoft.com/office/drawing/2014/main" xmlns="" id="{9BE9D757-5FBE-C84F-97BB-DC047979AB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75992" y="850921"/>
              <a:ext cx="720091" cy="3835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Non-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0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Reducing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xmlns="" id="{F27AF261-866F-DA4E-82C7-2D2646937D8A}"/>
              </a:ext>
            </a:extLst>
          </p:cNvPr>
          <p:cNvGrpSpPr/>
          <p:nvPr/>
        </p:nvGrpSpPr>
        <p:grpSpPr>
          <a:xfrm>
            <a:off x="1624789" y="4935147"/>
            <a:ext cx="3186181" cy="3894438"/>
            <a:chOff x="0" y="0"/>
            <a:chExt cx="4206430" cy="5154612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xmlns="" id="{60ECFDAC-A563-0E48-AB03-05292A2BB3D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" y="0"/>
              <a:ext cx="4206429" cy="17166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xmlns="" id="{CFA7E39C-23EC-0F4E-B1B1-64EE34FD24D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1721334"/>
              <a:ext cx="4206429" cy="17166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xmlns="" id="{DE509765-B6D4-624F-8E8E-3B556AA1AB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653" y="199371"/>
              <a:ext cx="1120508" cy="463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1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(a) PBS</a:t>
              </a:r>
              <a:endPara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1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    t = 0h</a:t>
              </a:r>
              <a:endPara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xmlns="" id="{AA003563-46D9-2D46-A8A6-9A14E88263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019" y="1842706"/>
              <a:ext cx="1126142" cy="463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1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(b) PBS </a:t>
              </a:r>
              <a:endPara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1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    t = 18h</a:t>
              </a:r>
              <a:endPara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xmlns="" id="{15E2BB5F-3A2A-7640-9631-0A7A5CE88F4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3437973"/>
              <a:ext cx="4206429" cy="17166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xmlns="" id="{D3E8E4C2-3FF0-CA4C-91D1-BB5DC78F1F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019" y="3624293"/>
              <a:ext cx="1126142" cy="463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1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(c) IMDM </a:t>
              </a:r>
              <a:endPara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1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S PGothic" panose="020B0600070205080204" pitchFamily="34" charset="-128"/>
                  <a:cs typeface="Times New Roman" panose="02020603050405020304" pitchFamily="18" charset="0"/>
                </a:rPr>
                <a:t>      t = 18h</a:t>
              </a:r>
              <a:endPara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" name="TextBox 8">
            <a:extLst>
              <a:ext uri="{FF2B5EF4-FFF2-40B4-BE49-F238E27FC236}">
                <a16:creationId xmlns:a16="http://schemas.microsoft.com/office/drawing/2014/main" xmlns="" id="{5503B33F-5F12-B44E-89B5-D7994FB071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70154" y="1203806"/>
            <a:ext cx="845103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marL="0" marR="0" algn="ctr" fontAlgn="base">
              <a:spcBef>
                <a:spcPts val="0"/>
              </a:spcBef>
              <a:spcAft>
                <a:spcPts val="0"/>
              </a:spcAft>
            </a:pPr>
            <a:r>
              <a:rPr lang="en-US" sz="105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Incubation </a:t>
            </a:r>
          </a:p>
          <a:p>
            <a:pPr marL="0" marR="0" algn="ctr" fontAlgn="base">
              <a:spcBef>
                <a:spcPts val="0"/>
              </a:spcBef>
              <a:spcAft>
                <a:spcPts val="0"/>
              </a:spcAft>
            </a:pPr>
            <a:r>
              <a:rPr lang="en-US" sz="105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time (h)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5412616E-C136-CC4B-B975-C71968016E2A}"/>
              </a:ext>
            </a:extLst>
          </p:cNvPr>
          <p:cNvSpPr txBox="1"/>
          <p:nvPr/>
        </p:nvSpPr>
        <p:spPr>
          <a:xfrm>
            <a:off x="568064" y="982777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0C4305DF-2F9C-BE49-8993-FDC68E919B59}"/>
              </a:ext>
            </a:extLst>
          </p:cNvPr>
          <p:cNvSpPr txBox="1"/>
          <p:nvPr/>
        </p:nvSpPr>
        <p:spPr>
          <a:xfrm>
            <a:off x="568064" y="4766696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AFDD5EB6-9D82-4442-9F8C-C75E02BC2FF7}"/>
              </a:ext>
            </a:extLst>
          </p:cNvPr>
          <p:cNvSpPr txBox="1"/>
          <p:nvPr/>
        </p:nvSpPr>
        <p:spPr>
          <a:xfrm>
            <a:off x="134112" y="269187"/>
            <a:ext cx="67238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S2</a:t>
            </a:r>
          </a:p>
        </p:txBody>
      </p:sp>
    </p:spTree>
    <p:extLst>
      <p:ext uri="{BB962C8B-B14F-4D97-AF65-F5344CB8AC3E}">
        <p14:creationId xmlns:p14="http://schemas.microsoft.com/office/powerpoint/2010/main" val="2683649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249</TotalTime>
  <Words>73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PGothic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ajeshwari A.</cp:lastModifiedBy>
  <cp:revision>524</cp:revision>
  <cp:lastPrinted>2019-10-09T17:57:08Z</cp:lastPrinted>
  <dcterms:created xsi:type="dcterms:W3CDTF">2019-08-20T22:35:14Z</dcterms:created>
  <dcterms:modified xsi:type="dcterms:W3CDTF">2021-12-10T14:10:20Z</dcterms:modified>
</cp:coreProperties>
</file>